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892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6F1604-BAC6-4DC4-8EB4-065E94F7CF98}" type="datetimeFigureOut">
              <a:rPr lang="zh-CN" altLang="en-US" smtClean="0"/>
              <a:pPr/>
              <a:t>2018/8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3E8BFA-198A-4F9A-978D-AADA9F2D22C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6F1604-BAC6-4DC4-8EB4-065E94F7CF98}" type="datetimeFigureOut">
              <a:rPr lang="zh-CN" altLang="en-US" smtClean="0"/>
              <a:pPr/>
              <a:t>2018/8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3E8BFA-198A-4F9A-978D-AADA9F2D22C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6F1604-BAC6-4DC4-8EB4-065E94F7CF98}" type="datetimeFigureOut">
              <a:rPr lang="zh-CN" altLang="en-US" smtClean="0"/>
              <a:pPr/>
              <a:t>2018/8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3E8BFA-198A-4F9A-978D-AADA9F2D22C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6F1604-BAC6-4DC4-8EB4-065E94F7CF98}" type="datetimeFigureOut">
              <a:rPr lang="zh-CN" altLang="en-US" smtClean="0"/>
              <a:pPr/>
              <a:t>2018/8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3E8BFA-198A-4F9A-978D-AADA9F2D22C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6F1604-BAC6-4DC4-8EB4-065E94F7CF98}" type="datetimeFigureOut">
              <a:rPr lang="zh-CN" altLang="en-US" smtClean="0"/>
              <a:pPr/>
              <a:t>2018/8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3E8BFA-198A-4F9A-978D-AADA9F2D22C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6F1604-BAC6-4DC4-8EB4-065E94F7CF98}" type="datetimeFigureOut">
              <a:rPr lang="zh-CN" altLang="en-US" smtClean="0"/>
              <a:pPr/>
              <a:t>2018/8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3E8BFA-198A-4F9A-978D-AADA9F2D22C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6F1604-BAC6-4DC4-8EB4-065E94F7CF98}" type="datetimeFigureOut">
              <a:rPr lang="zh-CN" altLang="en-US" smtClean="0"/>
              <a:pPr/>
              <a:t>2018/8/1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3E8BFA-198A-4F9A-978D-AADA9F2D22C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6F1604-BAC6-4DC4-8EB4-065E94F7CF98}" type="datetimeFigureOut">
              <a:rPr lang="zh-CN" altLang="en-US" smtClean="0"/>
              <a:pPr/>
              <a:t>2018/8/1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3E8BFA-198A-4F9A-978D-AADA9F2D22C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6F1604-BAC6-4DC4-8EB4-065E94F7CF98}" type="datetimeFigureOut">
              <a:rPr lang="zh-CN" altLang="en-US" smtClean="0"/>
              <a:pPr/>
              <a:t>2018/8/1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3E8BFA-198A-4F9A-978D-AADA9F2D22C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6F1604-BAC6-4DC4-8EB4-065E94F7CF98}" type="datetimeFigureOut">
              <a:rPr lang="zh-CN" altLang="en-US" smtClean="0"/>
              <a:pPr/>
              <a:t>2018/8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3E8BFA-198A-4F9A-978D-AADA9F2D22C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6F1604-BAC6-4DC4-8EB4-065E94F7CF98}" type="datetimeFigureOut">
              <a:rPr lang="zh-CN" altLang="en-US" smtClean="0"/>
              <a:pPr/>
              <a:t>2018/8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3E8BFA-198A-4F9A-978D-AADA9F2D22C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6F1604-BAC6-4DC4-8EB4-065E94F7CF98}" type="datetimeFigureOut">
              <a:rPr lang="zh-CN" altLang="en-US" smtClean="0"/>
              <a:pPr/>
              <a:t>2018/8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3E8BFA-198A-4F9A-978D-AADA9F2D22C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-4125" y="0"/>
            <a:ext cx="22718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Supplementary </a:t>
            </a:r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Fig.3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5" name="图片 4" descr="SFig.3.jpg"/>
          <p:cNvPicPr>
            <a:picLocks noChangeAspect="1"/>
          </p:cNvPicPr>
          <p:nvPr/>
        </p:nvPicPr>
        <p:blipFill>
          <a:blip r:embed="rId2" cstate="print">
            <a:lum contrast="20000"/>
          </a:blip>
          <a:stretch>
            <a:fillRect/>
          </a:stretch>
        </p:blipFill>
        <p:spPr>
          <a:xfrm>
            <a:off x="2115176" y="3160157"/>
            <a:ext cx="1014222" cy="1272075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 rot="-5400000">
            <a:off x="693895" y="3736696"/>
            <a:ext cx="1981199" cy="4514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400"/>
              </a:lnSpc>
            </a:pP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% Change in </a:t>
            </a:r>
            <a:r>
              <a:rPr lang="en-US" altLang="zh-CN" sz="1000" b="1" dirty="0" err="1" smtClean="0">
                <a:latin typeface="Arial" pitchFamily="34" charset="0"/>
                <a:cs typeface="Arial" pitchFamily="34" charset="0"/>
              </a:rPr>
              <a:t>evans</a:t>
            </a: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 blue absorbance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 rot="-2400000">
            <a:off x="2126626" y="4604251"/>
            <a:ext cx="100965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miR-320-3p </a:t>
            </a:r>
            <a:r>
              <a:rPr lang="en-US" altLang="zh-CN" sz="700" b="1" dirty="0" err="1" smtClean="0">
                <a:latin typeface="Arial" pitchFamily="34" charset="0"/>
                <a:cs typeface="Arial" pitchFamily="34" charset="0"/>
              </a:rPr>
              <a:t>agomir</a:t>
            </a:r>
            <a:endParaRPr lang="zh-CN" altLang="en-US" sz="700" dirty="0"/>
          </a:p>
        </p:txBody>
      </p:sp>
      <p:sp>
        <p:nvSpPr>
          <p:cNvPr id="8" name="TextBox 7"/>
          <p:cNvSpPr txBox="1"/>
          <p:nvPr/>
        </p:nvSpPr>
        <p:spPr>
          <a:xfrm rot="-2400000">
            <a:off x="1780188" y="4604251"/>
            <a:ext cx="100965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Scramble </a:t>
            </a:r>
            <a:r>
              <a:rPr lang="en-US" altLang="zh-CN" sz="700" b="1" dirty="0" err="1" smtClean="0">
                <a:latin typeface="Arial" pitchFamily="34" charset="0"/>
                <a:cs typeface="Arial" pitchFamily="34" charset="0"/>
              </a:rPr>
              <a:t>agomir</a:t>
            </a:r>
            <a:endParaRPr lang="zh-CN" altLang="en-US" sz="700" dirty="0"/>
          </a:p>
        </p:txBody>
      </p:sp>
      <p:sp>
        <p:nvSpPr>
          <p:cNvPr id="9" name="TextBox 8"/>
          <p:cNvSpPr txBox="1"/>
          <p:nvPr/>
        </p:nvSpPr>
        <p:spPr>
          <a:xfrm>
            <a:off x="2413934" y="3220301"/>
            <a:ext cx="365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741594" y="3160157"/>
            <a:ext cx="365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371600" y="2818754"/>
            <a:ext cx="4281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540794" y="2820955"/>
            <a:ext cx="4281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14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3" name="图片 12" descr="SFig.3B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3934019" y="4286250"/>
            <a:ext cx="822480" cy="498729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4663066" y="4301762"/>
            <a:ext cx="616390" cy="2059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-TESTIN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693801" y="4594688"/>
            <a:ext cx="616390" cy="2059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-ACTIN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 rot="-3000000">
            <a:off x="4212447" y="3850893"/>
            <a:ext cx="100965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miR-320-3p </a:t>
            </a:r>
            <a:r>
              <a:rPr lang="en-US" altLang="zh-CN" sz="700" b="1" dirty="0" err="1" smtClean="0">
                <a:latin typeface="Arial" pitchFamily="34" charset="0"/>
                <a:cs typeface="Arial" pitchFamily="34" charset="0"/>
              </a:rPr>
              <a:t>agomir</a:t>
            </a:r>
            <a:endParaRPr lang="zh-CN" altLang="en-US" sz="700" dirty="0"/>
          </a:p>
        </p:txBody>
      </p:sp>
      <p:sp>
        <p:nvSpPr>
          <p:cNvPr id="17" name="TextBox 16"/>
          <p:cNvSpPr txBox="1"/>
          <p:nvPr/>
        </p:nvSpPr>
        <p:spPr>
          <a:xfrm rot="-3000000">
            <a:off x="3741890" y="3945947"/>
            <a:ext cx="100965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Scramble </a:t>
            </a:r>
            <a:r>
              <a:rPr lang="en-US" altLang="zh-CN" sz="700" b="1" dirty="0" err="1" smtClean="0">
                <a:latin typeface="Arial" pitchFamily="34" charset="0"/>
                <a:cs typeface="Arial" pitchFamily="34" charset="0"/>
              </a:rPr>
              <a:t>agomir</a:t>
            </a:r>
            <a:endParaRPr lang="zh-CN" altLang="en-US" sz="7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7</TotalTime>
  <Words>24</Words>
  <Application>Microsoft Office PowerPoint</Application>
  <PresentationFormat>全屏显示(4:3)</PresentationFormat>
  <Paragraphs>12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dministrator</dc:creator>
  <cp:lastModifiedBy>Administrator</cp:lastModifiedBy>
  <cp:revision>12</cp:revision>
  <dcterms:created xsi:type="dcterms:W3CDTF">2017-11-26T13:38:37Z</dcterms:created>
  <dcterms:modified xsi:type="dcterms:W3CDTF">2018-08-13T12:25:07Z</dcterms:modified>
</cp:coreProperties>
</file>